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1"/>
  </p:handoutMasterIdLst>
  <p:sldIdLst>
    <p:sldId id="258" r:id="rId4"/>
    <p:sldId id="264" r:id="rId5"/>
    <p:sldId id="266" r:id="rId6"/>
    <p:sldId id="267" r:id="rId7"/>
    <p:sldId id="270" r:id="rId8"/>
    <p:sldId id="268" r:id="rId9"/>
    <p:sldId id="265" r:id="rId10"/>
  </p:sldIdLst>
  <p:sldSz cx="9144000" cy="6858000" type="screen4x3"/>
  <p:notesSz cx="6858000" cy="9144000"/>
  <p:custDataLst>
    <p:tags r:id="rId12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4F7279D-E1D4-4059-BA78-83247A24E7EF}" v="40" dt="2023-05-02T04:30:19.450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901" autoAdjust="0"/>
    <p:restoredTop sz="94674" autoAdjust="0"/>
  </p:normalViewPr>
  <p:slideViewPr>
    <p:cSldViewPr>
      <p:cViewPr varScale="1">
        <p:scale>
          <a:sx n="74" d="100"/>
          <a:sy n="74" d="100"/>
        </p:scale>
        <p:origin x="1032" y="5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presProps" Target="presProps.xml"/><Relationship Id="rId18" Type="http://schemas.microsoft.com/office/2015/10/relationships/revisionInfo" Target="revisionInfo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tags" Target="tags/tag1.xml"/><Relationship Id="rId17" Type="http://schemas.microsoft.com/office/2016/11/relationships/changesInfo" Target="changesInfos/changesInfo1.xml"/><Relationship Id="rId2" Type="http://schemas.openxmlformats.org/officeDocument/2006/relationships/slideMaster" Target="slideMasters/slideMaster2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handoutMaster" Target="handoutMasters/handoutMaster1.xml"/><Relationship Id="rId5" Type="http://schemas.openxmlformats.org/officeDocument/2006/relationships/slide" Target="slides/slide2.xml"/><Relationship Id="rId15" Type="http://schemas.openxmlformats.org/officeDocument/2006/relationships/theme" Target="theme/theme1.xml"/><Relationship Id="rId10" Type="http://schemas.openxmlformats.org/officeDocument/2006/relationships/slide" Target="slides/slide7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ahita TAVOOSI" userId="c435fe4c-c5c9-4be8-a0a0-7eec80ace3b3" providerId="ADAL" clId="{F4F7279D-E1D4-4059-BA78-83247A24E7EF}"/>
    <pc:docChg chg="undo redo custSel modSld sldOrd">
      <pc:chgData name="Anahita TAVOOSI" userId="c435fe4c-c5c9-4be8-a0a0-7eec80ace3b3" providerId="ADAL" clId="{F4F7279D-E1D4-4059-BA78-83247A24E7EF}" dt="2023-05-02T04:30:19.449" v="424" actId="14100"/>
      <pc:docMkLst>
        <pc:docMk/>
      </pc:docMkLst>
      <pc:sldChg chg="addSp delSp modSp mod">
        <pc:chgData name="Anahita TAVOOSI" userId="c435fe4c-c5c9-4be8-a0a0-7eec80ace3b3" providerId="ADAL" clId="{F4F7279D-E1D4-4059-BA78-83247A24E7EF}" dt="2023-05-02T04:27:02.864" v="415" actId="1037"/>
        <pc:sldMkLst>
          <pc:docMk/>
          <pc:sldMk cId="0" sldId="258"/>
        </pc:sldMkLst>
        <pc:spChg chg="del">
          <ac:chgData name="Anahita TAVOOSI" userId="c435fe4c-c5c9-4be8-a0a0-7eec80ace3b3" providerId="ADAL" clId="{F4F7279D-E1D4-4059-BA78-83247A24E7EF}" dt="2023-05-02T04:14:09.433" v="352" actId="478"/>
          <ac:spMkLst>
            <pc:docMk/>
            <pc:sldMk cId="0" sldId="258"/>
            <ac:spMk id="2" creationId="{00000000-0000-0000-0000-000000000000}"/>
          </ac:spMkLst>
        </pc:spChg>
        <pc:spChg chg="del">
          <ac:chgData name="Anahita TAVOOSI" userId="c435fe4c-c5c9-4be8-a0a0-7eec80ace3b3" providerId="ADAL" clId="{F4F7279D-E1D4-4059-BA78-83247A24E7EF}" dt="2023-05-02T04:16:38.282" v="363" actId="478"/>
          <ac:spMkLst>
            <pc:docMk/>
            <pc:sldMk cId="0" sldId="258"/>
            <ac:spMk id="10" creationId="{00000000-0000-0000-0000-000000000000}"/>
          </ac:spMkLst>
        </pc:spChg>
        <pc:spChg chg="mod">
          <ac:chgData name="Anahita TAVOOSI" userId="c435fe4c-c5c9-4be8-a0a0-7eec80ace3b3" providerId="ADAL" clId="{F4F7279D-E1D4-4059-BA78-83247A24E7EF}" dt="2023-05-02T03:09:59.344" v="8"/>
          <ac:spMkLst>
            <pc:docMk/>
            <pc:sldMk cId="0" sldId="258"/>
            <ac:spMk id="4102" creationId="{00000000-0000-0000-0000-000000000000}"/>
          </ac:spMkLst>
        </pc:spChg>
        <pc:spChg chg="mod">
          <ac:chgData name="Anahita TAVOOSI" userId="c435fe4c-c5c9-4be8-a0a0-7eec80ace3b3" providerId="ADAL" clId="{F4F7279D-E1D4-4059-BA78-83247A24E7EF}" dt="2023-05-02T04:20:36.377" v="378"/>
          <ac:spMkLst>
            <pc:docMk/>
            <pc:sldMk cId="0" sldId="258"/>
            <ac:spMk id="4103" creationId="{00000000-0000-0000-0000-000000000000}"/>
          </ac:spMkLst>
        </pc:spChg>
        <pc:spChg chg="del">
          <ac:chgData name="Anahita TAVOOSI" userId="c435fe4c-c5c9-4be8-a0a0-7eec80ace3b3" providerId="ADAL" clId="{F4F7279D-E1D4-4059-BA78-83247A24E7EF}" dt="2023-05-02T03:17:28.703" v="19" actId="478"/>
          <ac:spMkLst>
            <pc:docMk/>
            <pc:sldMk cId="0" sldId="258"/>
            <ac:spMk id="4104" creationId="{00000000-0000-0000-0000-000000000000}"/>
          </ac:spMkLst>
        </pc:spChg>
        <pc:picChg chg="add mod modCrop">
          <ac:chgData name="Anahita TAVOOSI" userId="c435fe4c-c5c9-4be8-a0a0-7eec80ace3b3" providerId="ADAL" clId="{F4F7279D-E1D4-4059-BA78-83247A24E7EF}" dt="2023-05-02T04:17:07.261" v="368" actId="14100"/>
          <ac:picMkLst>
            <pc:docMk/>
            <pc:sldMk cId="0" sldId="258"/>
            <ac:picMk id="5" creationId="{8A1386F1-44F8-604A-848D-917F2B9393D4}"/>
          </ac:picMkLst>
        </pc:picChg>
        <pc:picChg chg="add mod">
          <ac:chgData name="Anahita TAVOOSI" userId="c435fe4c-c5c9-4be8-a0a0-7eec80ace3b3" providerId="ADAL" clId="{F4F7279D-E1D4-4059-BA78-83247A24E7EF}" dt="2023-05-02T04:26:45.230" v="410" actId="1076"/>
          <ac:picMkLst>
            <pc:docMk/>
            <pc:sldMk cId="0" sldId="258"/>
            <ac:picMk id="6" creationId="{AE01D2C5-3CCF-CE82-6702-0AC946AF7443}"/>
          </ac:picMkLst>
        </pc:picChg>
        <pc:picChg chg="add mod">
          <ac:chgData name="Anahita TAVOOSI" userId="c435fe4c-c5c9-4be8-a0a0-7eec80ace3b3" providerId="ADAL" clId="{F4F7279D-E1D4-4059-BA78-83247A24E7EF}" dt="2023-05-02T04:26:38.140" v="408" actId="14100"/>
          <ac:picMkLst>
            <pc:docMk/>
            <pc:sldMk cId="0" sldId="258"/>
            <ac:picMk id="7" creationId="{067ABB67-A034-51A7-F1CE-F0D33DC900A5}"/>
          </ac:picMkLst>
        </pc:picChg>
        <pc:picChg chg="add mod">
          <ac:chgData name="Anahita TAVOOSI" userId="c435fe4c-c5c9-4be8-a0a0-7eec80ace3b3" providerId="ADAL" clId="{F4F7279D-E1D4-4059-BA78-83247A24E7EF}" dt="2023-05-02T04:26:34.111" v="407" actId="14100"/>
          <ac:picMkLst>
            <pc:docMk/>
            <pc:sldMk cId="0" sldId="258"/>
            <ac:picMk id="8" creationId="{F4ADF24D-3C35-6307-1F11-08EA98C8E4AC}"/>
          </ac:picMkLst>
        </pc:picChg>
        <pc:picChg chg="add del mod">
          <ac:chgData name="Anahita TAVOOSI" userId="c435fe4c-c5c9-4be8-a0a0-7eec80ace3b3" providerId="ADAL" clId="{F4F7279D-E1D4-4059-BA78-83247A24E7EF}" dt="2023-05-02T04:21:44.262" v="384" actId="478"/>
          <ac:picMkLst>
            <pc:docMk/>
            <pc:sldMk cId="0" sldId="258"/>
            <ac:picMk id="12" creationId="{2CCB9B29-B1A3-56A4-44CA-6219D0387B8D}"/>
          </ac:picMkLst>
        </pc:picChg>
        <pc:picChg chg="add mod modCrop">
          <ac:chgData name="Anahita TAVOOSI" userId="c435fe4c-c5c9-4be8-a0a0-7eec80ace3b3" providerId="ADAL" clId="{F4F7279D-E1D4-4059-BA78-83247A24E7EF}" dt="2023-05-02T04:27:02.864" v="415" actId="1037"/>
          <ac:picMkLst>
            <pc:docMk/>
            <pc:sldMk cId="0" sldId="258"/>
            <ac:picMk id="14" creationId="{8DFA99E7-4B2F-7E89-551B-C7B8635EAEB0}"/>
          </ac:picMkLst>
        </pc:picChg>
        <pc:picChg chg="add mod">
          <ac:chgData name="Anahita TAVOOSI" userId="c435fe4c-c5c9-4be8-a0a0-7eec80ace3b3" providerId="ADAL" clId="{F4F7279D-E1D4-4059-BA78-83247A24E7EF}" dt="2023-05-02T04:26:30.198" v="406" actId="14100"/>
          <ac:picMkLst>
            <pc:docMk/>
            <pc:sldMk cId="0" sldId="258"/>
            <ac:picMk id="2050" creationId="{865AA86F-69C9-BEFE-FEEE-41B68B701449}"/>
          </ac:picMkLst>
        </pc:picChg>
      </pc:sldChg>
      <pc:sldChg chg="modSp mod">
        <pc:chgData name="Anahita TAVOOSI" userId="c435fe4c-c5c9-4be8-a0a0-7eec80ace3b3" providerId="ADAL" clId="{F4F7279D-E1D4-4059-BA78-83247A24E7EF}" dt="2023-05-02T04:30:19.449" v="424" actId="14100"/>
        <pc:sldMkLst>
          <pc:docMk/>
          <pc:sldMk cId="0" sldId="264"/>
        </pc:sldMkLst>
        <pc:spChg chg="mod">
          <ac:chgData name="Anahita TAVOOSI" userId="c435fe4c-c5c9-4be8-a0a0-7eec80ace3b3" providerId="ADAL" clId="{F4F7279D-E1D4-4059-BA78-83247A24E7EF}" dt="2023-05-02T04:30:19.449" v="424" actId="14100"/>
          <ac:spMkLst>
            <pc:docMk/>
            <pc:sldMk cId="0" sldId="264"/>
            <ac:spMk id="6151" creationId="{00000000-0000-0000-0000-000000000000}"/>
          </ac:spMkLst>
        </pc:spChg>
      </pc:sldChg>
      <pc:sldChg chg="modSp mod">
        <pc:chgData name="Anahita TAVOOSI" userId="c435fe4c-c5c9-4be8-a0a0-7eec80ace3b3" providerId="ADAL" clId="{F4F7279D-E1D4-4059-BA78-83247A24E7EF}" dt="2023-05-02T04:29:38.538" v="422" actId="20577"/>
        <pc:sldMkLst>
          <pc:docMk/>
          <pc:sldMk cId="2545659868" sldId="265"/>
        </pc:sldMkLst>
        <pc:spChg chg="mod">
          <ac:chgData name="Anahita TAVOOSI" userId="c435fe4c-c5c9-4be8-a0a0-7eec80ace3b3" providerId="ADAL" clId="{F4F7279D-E1D4-4059-BA78-83247A24E7EF}" dt="2023-05-02T03:46:47.315" v="209" actId="20577"/>
          <ac:spMkLst>
            <pc:docMk/>
            <pc:sldMk cId="2545659868" sldId="265"/>
            <ac:spMk id="7" creationId="{00000000-0000-0000-0000-000000000000}"/>
          </ac:spMkLst>
        </pc:spChg>
        <pc:spChg chg="mod">
          <ac:chgData name="Anahita TAVOOSI" userId="c435fe4c-c5c9-4be8-a0a0-7eec80ace3b3" providerId="ADAL" clId="{F4F7279D-E1D4-4059-BA78-83247A24E7EF}" dt="2023-05-02T04:29:38.538" v="422" actId="20577"/>
          <ac:spMkLst>
            <pc:docMk/>
            <pc:sldMk cId="2545659868" sldId="265"/>
            <ac:spMk id="6151" creationId="{00000000-0000-0000-0000-000000000000}"/>
          </ac:spMkLst>
        </pc:spChg>
      </pc:sldChg>
      <pc:sldChg chg="modSp mod">
        <pc:chgData name="Anahita TAVOOSI" userId="c435fe4c-c5c9-4be8-a0a0-7eec80ace3b3" providerId="ADAL" clId="{F4F7279D-E1D4-4059-BA78-83247A24E7EF}" dt="2023-05-02T04:28:19.444" v="417" actId="20577"/>
        <pc:sldMkLst>
          <pc:docMk/>
          <pc:sldMk cId="3786696485" sldId="266"/>
        </pc:sldMkLst>
        <pc:spChg chg="mod">
          <ac:chgData name="Anahita TAVOOSI" userId="c435fe4c-c5c9-4be8-a0a0-7eec80ace3b3" providerId="ADAL" clId="{F4F7279D-E1D4-4059-BA78-83247A24E7EF}" dt="2023-05-02T04:28:19.444" v="417" actId="20577"/>
          <ac:spMkLst>
            <pc:docMk/>
            <pc:sldMk cId="3786696485" sldId="266"/>
            <ac:spMk id="6151" creationId="{00000000-0000-0000-0000-000000000000}"/>
          </ac:spMkLst>
        </pc:spChg>
      </pc:sldChg>
      <pc:sldChg chg="addSp delSp modSp mod">
        <pc:chgData name="Anahita TAVOOSI" userId="c435fe4c-c5c9-4be8-a0a0-7eec80ace3b3" providerId="ADAL" clId="{F4F7279D-E1D4-4059-BA78-83247A24E7EF}" dt="2023-05-02T04:11:06.621" v="350" actId="207"/>
        <pc:sldMkLst>
          <pc:docMk/>
          <pc:sldMk cId="218645169" sldId="267"/>
        </pc:sldMkLst>
        <pc:spChg chg="add del mod">
          <ac:chgData name="Anahita TAVOOSI" userId="c435fe4c-c5c9-4be8-a0a0-7eec80ace3b3" providerId="ADAL" clId="{F4F7279D-E1D4-4059-BA78-83247A24E7EF}" dt="2023-05-02T04:00:49.514" v="280"/>
          <ac:spMkLst>
            <pc:docMk/>
            <pc:sldMk cId="218645169" sldId="267"/>
            <ac:spMk id="3" creationId="{EFC1FC42-AE24-A081-BEF1-6E521CA868E6}"/>
          </ac:spMkLst>
        </pc:spChg>
        <pc:spChg chg="add del mod">
          <ac:chgData name="Anahita TAVOOSI" userId="c435fe4c-c5c9-4be8-a0a0-7eec80ace3b3" providerId="ADAL" clId="{F4F7279D-E1D4-4059-BA78-83247A24E7EF}" dt="2023-05-02T04:00:49.514" v="280"/>
          <ac:spMkLst>
            <pc:docMk/>
            <pc:sldMk cId="218645169" sldId="267"/>
            <ac:spMk id="5" creationId="{AFC13D44-94D9-8F9E-4CA5-A7D88C11493D}"/>
          </ac:spMkLst>
        </pc:spChg>
        <pc:spChg chg="add mod">
          <ac:chgData name="Anahita TAVOOSI" userId="c435fe4c-c5c9-4be8-a0a0-7eec80ace3b3" providerId="ADAL" clId="{F4F7279D-E1D4-4059-BA78-83247A24E7EF}" dt="2023-05-02T04:11:06.621" v="350" actId="207"/>
          <ac:spMkLst>
            <pc:docMk/>
            <pc:sldMk cId="218645169" sldId="267"/>
            <ac:spMk id="12" creationId="{F75F2ECB-A030-7164-518B-CC73DB617E3B}"/>
          </ac:spMkLst>
        </pc:spChg>
        <pc:spChg chg="mod">
          <ac:chgData name="Anahita TAVOOSI" userId="c435fe4c-c5c9-4be8-a0a0-7eec80ace3b3" providerId="ADAL" clId="{F4F7279D-E1D4-4059-BA78-83247A24E7EF}" dt="2023-05-02T03:59:10.543" v="276" actId="6549"/>
          <ac:spMkLst>
            <pc:docMk/>
            <pc:sldMk cId="218645169" sldId="267"/>
            <ac:spMk id="6151" creationId="{00000000-0000-0000-0000-000000000000}"/>
          </ac:spMkLst>
        </pc:spChg>
        <pc:graphicFrameChg chg="add del mod">
          <ac:chgData name="Anahita TAVOOSI" userId="c435fe4c-c5c9-4be8-a0a0-7eec80ace3b3" providerId="ADAL" clId="{F4F7279D-E1D4-4059-BA78-83247A24E7EF}" dt="2023-05-02T04:00:49.514" v="280"/>
          <ac:graphicFrameMkLst>
            <pc:docMk/>
            <pc:sldMk cId="218645169" sldId="267"/>
            <ac:graphicFrameMk id="2" creationId="{634AD47D-68AF-18BD-FFDF-7F3BB865F6D6}"/>
          </ac:graphicFrameMkLst>
        </pc:graphicFrameChg>
        <pc:picChg chg="add mod">
          <ac:chgData name="Anahita TAVOOSI" userId="c435fe4c-c5c9-4be8-a0a0-7eec80ace3b3" providerId="ADAL" clId="{F4F7279D-E1D4-4059-BA78-83247A24E7EF}" dt="2023-05-02T04:05:38.004" v="303" actId="1076"/>
          <ac:picMkLst>
            <pc:docMk/>
            <pc:sldMk cId="218645169" sldId="267"/>
            <ac:picMk id="6" creationId="{B1B08C5A-4EF5-2A5E-9E84-4C42C804D257}"/>
          </ac:picMkLst>
        </pc:picChg>
        <pc:picChg chg="add mod">
          <ac:chgData name="Anahita TAVOOSI" userId="c435fe4c-c5c9-4be8-a0a0-7eec80ace3b3" providerId="ADAL" clId="{F4F7279D-E1D4-4059-BA78-83247A24E7EF}" dt="2023-05-02T04:05:43.774" v="304" actId="1076"/>
          <ac:picMkLst>
            <pc:docMk/>
            <pc:sldMk cId="218645169" sldId="267"/>
            <ac:picMk id="9" creationId="{B1B3706C-E1E2-F338-7F0F-5A908F744B91}"/>
          </ac:picMkLst>
        </pc:picChg>
        <pc:picChg chg="add del mod">
          <ac:chgData name="Anahita TAVOOSI" userId="c435fe4c-c5c9-4be8-a0a0-7eec80ace3b3" providerId="ADAL" clId="{F4F7279D-E1D4-4059-BA78-83247A24E7EF}" dt="2023-05-02T04:00:49.514" v="280"/>
          <ac:picMkLst>
            <pc:docMk/>
            <pc:sldMk cId="218645169" sldId="267"/>
            <ac:picMk id="1025" creationId="{521693F6-A71A-4D46-C536-710B72574772}"/>
          </ac:picMkLst>
        </pc:picChg>
        <pc:picChg chg="add del mod">
          <ac:chgData name="Anahita TAVOOSI" userId="c435fe4c-c5c9-4be8-a0a0-7eec80ace3b3" providerId="ADAL" clId="{F4F7279D-E1D4-4059-BA78-83247A24E7EF}" dt="2023-05-02T04:00:49.514" v="280"/>
          <ac:picMkLst>
            <pc:docMk/>
            <pc:sldMk cId="218645169" sldId="267"/>
            <ac:picMk id="1026" creationId="{BCAA3EC0-427E-0284-C2B8-3203D4875559}"/>
          </ac:picMkLst>
        </pc:picChg>
      </pc:sldChg>
      <pc:sldChg chg="addSp modSp mod ord">
        <pc:chgData name="Anahita TAVOOSI" userId="c435fe4c-c5c9-4be8-a0a0-7eec80ace3b3" providerId="ADAL" clId="{F4F7279D-E1D4-4059-BA78-83247A24E7EF}" dt="2023-05-02T04:28:54.731" v="419"/>
        <pc:sldMkLst>
          <pc:docMk/>
          <pc:sldMk cId="1176960746" sldId="268"/>
        </pc:sldMkLst>
        <pc:spChg chg="add mod">
          <ac:chgData name="Anahita TAVOOSI" userId="c435fe4c-c5c9-4be8-a0a0-7eec80ace3b3" providerId="ADAL" clId="{F4F7279D-E1D4-4059-BA78-83247A24E7EF}" dt="2023-05-02T04:10:24.494" v="349" actId="1076"/>
          <ac:spMkLst>
            <pc:docMk/>
            <pc:sldMk cId="1176960746" sldId="268"/>
            <ac:spMk id="6" creationId="{27146D1A-DA1B-14CD-CADD-4D0F0770BFB7}"/>
          </ac:spMkLst>
        </pc:spChg>
        <pc:spChg chg="mod">
          <ac:chgData name="Anahita TAVOOSI" userId="c435fe4c-c5c9-4be8-a0a0-7eec80ace3b3" providerId="ADAL" clId="{F4F7279D-E1D4-4059-BA78-83247A24E7EF}" dt="2023-05-02T04:07:22.041" v="318" actId="14100"/>
          <ac:spMkLst>
            <pc:docMk/>
            <pc:sldMk cId="1176960746" sldId="268"/>
            <ac:spMk id="6151" creationId="{00000000-0000-0000-0000-000000000000}"/>
          </ac:spMkLst>
        </pc:spChg>
        <pc:picChg chg="add mod modCrop">
          <ac:chgData name="Anahita TAVOOSI" userId="c435fe4c-c5c9-4be8-a0a0-7eec80ace3b3" providerId="ADAL" clId="{F4F7279D-E1D4-4059-BA78-83247A24E7EF}" dt="2023-05-02T04:09:31.552" v="342" actId="732"/>
          <ac:picMkLst>
            <pc:docMk/>
            <pc:sldMk cId="1176960746" sldId="268"/>
            <ac:picMk id="2" creationId="{2E470A36-86D1-7D40-4213-F87C08E46FCD}"/>
          </ac:picMkLst>
        </pc:picChg>
        <pc:picChg chg="add mod modCrop">
          <ac:chgData name="Anahita TAVOOSI" userId="c435fe4c-c5c9-4be8-a0a0-7eec80ace3b3" providerId="ADAL" clId="{F4F7279D-E1D4-4059-BA78-83247A24E7EF}" dt="2023-05-02T04:10:17.680" v="348" actId="1076"/>
          <ac:picMkLst>
            <pc:docMk/>
            <pc:sldMk cId="1176960746" sldId="268"/>
            <ac:picMk id="3" creationId="{901D2430-784A-D503-E8DB-A218CFA6EC0E}"/>
          </ac:picMkLst>
        </pc:picChg>
        <pc:picChg chg="add mod modCrop">
          <ac:chgData name="Anahita TAVOOSI" userId="c435fe4c-c5c9-4be8-a0a0-7eec80ace3b3" providerId="ADAL" clId="{F4F7279D-E1D4-4059-BA78-83247A24E7EF}" dt="2023-05-02T04:09:02.321" v="337" actId="732"/>
          <ac:picMkLst>
            <pc:docMk/>
            <pc:sldMk cId="1176960746" sldId="268"/>
            <ac:picMk id="5" creationId="{97442154-3E20-AC35-06CA-62C79D3A8FC1}"/>
          </ac:picMkLst>
        </pc:picChg>
      </pc:sldChg>
    </pc:docChg>
  </pc:docChgLst>
  <pc:docChgLst>
    <pc:chgData name="Rob deKemp" userId="26657504-1aab-467a-88b1-a1249bc920d0" providerId="ADAL" clId="{AF186694-5EC4-4370-A5C7-D5DC4E26AB08}"/>
    <pc:docChg chg="undo redo custSel addSld delSld modSld sldOrd">
      <pc:chgData name="Rob deKemp" userId="26657504-1aab-467a-88b1-a1249bc920d0" providerId="ADAL" clId="{AF186694-5EC4-4370-A5C7-D5DC4E26AB08}" dt="2023-05-02T20:53:11.288" v="379" actId="164"/>
      <pc:docMkLst>
        <pc:docMk/>
      </pc:docMkLst>
      <pc:sldChg chg="delSp modSp mod">
        <pc:chgData name="Rob deKemp" userId="26657504-1aab-467a-88b1-a1249bc920d0" providerId="ADAL" clId="{AF186694-5EC4-4370-A5C7-D5DC4E26AB08}" dt="2023-05-02T20:52:01.985" v="370" actId="1076"/>
        <pc:sldMkLst>
          <pc:docMk/>
          <pc:sldMk cId="0" sldId="258"/>
        </pc:sldMkLst>
        <pc:spChg chg="mod">
          <ac:chgData name="Rob deKemp" userId="26657504-1aab-467a-88b1-a1249bc920d0" providerId="ADAL" clId="{AF186694-5EC4-4370-A5C7-D5DC4E26AB08}" dt="2023-05-02T20:51:41.741" v="365" actId="255"/>
          <ac:spMkLst>
            <pc:docMk/>
            <pc:sldMk cId="0" sldId="258"/>
            <ac:spMk id="4102" creationId="{00000000-0000-0000-0000-000000000000}"/>
          </ac:spMkLst>
        </pc:spChg>
        <pc:picChg chg="mod">
          <ac:chgData name="Rob deKemp" userId="26657504-1aab-467a-88b1-a1249bc920d0" providerId="ADAL" clId="{AF186694-5EC4-4370-A5C7-D5DC4E26AB08}" dt="2023-05-02T20:52:01.985" v="370" actId="1076"/>
          <ac:picMkLst>
            <pc:docMk/>
            <pc:sldMk cId="0" sldId="258"/>
            <ac:picMk id="5" creationId="{8A1386F1-44F8-604A-848D-917F2B9393D4}"/>
          </ac:picMkLst>
        </pc:picChg>
        <pc:picChg chg="mod">
          <ac:chgData name="Rob deKemp" userId="26657504-1aab-467a-88b1-a1249bc920d0" providerId="ADAL" clId="{AF186694-5EC4-4370-A5C7-D5DC4E26AB08}" dt="2023-05-02T20:51:48.966" v="366" actId="1076"/>
          <ac:picMkLst>
            <pc:docMk/>
            <pc:sldMk cId="0" sldId="258"/>
            <ac:picMk id="6" creationId="{AE01D2C5-3CCF-CE82-6702-0AC946AF7443}"/>
          </ac:picMkLst>
        </pc:picChg>
        <pc:picChg chg="mod">
          <ac:chgData name="Rob deKemp" userId="26657504-1aab-467a-88b1-a1249bc920d0" providerId="ADAL" clId="{AF186694-5EC4-4370-A5C7-D5DC4E26AB08}" dt="2023-05-02T20:51:50.754" v="367" actId="1076"/>
          <ac:picMkLst>
            <pc:docMk/>
            <pc:sldMk cId="0" sldId="258"/>
            <ac:picMk id="7" creationId="{067ABB67-A034-51A7-F1CE-F0D33DC900A5}"/>
          </ac:picMkLst>
        </pc:picChg>
        <pc:picChg chg="del">
          <ac:chgData name="Rob deKemp" userId="26657504-1aab-467a-88b1-a1249bc920d0" providerId="ADAL" clId="{AF186694-5EC4-4370-A5C7-D5DC4E26AB08}" dt="2023-05-02T19:32:54.733" v="2" actId="478"/>
          <ac:picMkLst>
            <pc:docMk/>
            <pc:sldMk cId="0" sldId="258"/>
            <ac:picMk id="8" creationId="{F4ADF24D-3C35-6307-1F11-08EA98C8E4AC}"/>
          </ac:picMkLst>
        </pc:picChg>
        <pc:picChg chg="del">
          <ac:chgData name="Rob deKemp" userId="26657504-1aab-467a-88b1-a1249bc920d0" providerId="ADAL" clId="{AF186694-5EC4-4370-A5C7-D5DC4E26AB08}" dt="2023-05-02T19:32:46.077" v="0" actId="478"/>
          <ac:picMkLst>
            <pc:docMk/>
            <pc:sldMk cId="0" sldId="258"/>
            <ac:picMk id="14" creationId="{8DFA99E7-4B2F-7E89-551B-C7B8635EAEB0}"/>
          </ac:picMkLst>
        </pc:picChg>
        <pc:picChg chg="del">
          <ac:chgData name="Rob deKemp" userId="26657504-1aab-467a-88b1-a1249bc920d0" providerId="ADAL" clId="{AF186694-5EC4-4370-A5C7-D5DC4E26AB08}" dt="2023-05-02T19:32:47.618" v="1" actId="478"/>
          <ac:picMkLst>
            <pc:docMk/>
            <pc:sldMk cId="0" sldId="258"/>
            <ac:picMk id="2050" creationId="{865AA86F-69C9-BEFE-FEEE-41B68B701449}"/>
          </ac:picMkLst>
        </pc:picChg>
      </pc:sldChg>
      <pc:sldChg chg="modSp mod">
        <pc:chgData name="Rob deKemp" userId="26657504-1aab-467a-88b1-a1249bc920d0" providerId="ADAL" clId="{AF186694-5EC4-4370-A5C7-D5DC4E26AB08}" dt="2023-05-02T20:05:35.090" v="86" actId="20577"/>
        <pc:sldMkLst>
          <pc:docMk/>
          <pc:sldMk cId="0" sldId="264"/>
        </pc:sldMkLst>
        <pc:spChg chg="mod">
          <ac:chgData name="Rob deKemp" userId="26657504-1aab-467a-88b1-a1249bc920d0" providerId="ADAL" clId="{AF186694-5EC4-4370-A5C7-D5DC4E26AB08}" dt="2023-05-02T20:05:35.090" v="86" actId="20577"/>
          <ac:spMkLst>
            <pc:docMk/>
            <pc:sldMk cId="0" sldId="264"/>
            <ac:spMk id="6151" creationId="{00000000-0000-0000-0000-000000000000}"/>
          </ac:spMkLst>
        </pc:spChg>
      </pc:sldChg>
      <pc:sldChg chg="modSp mod">
        <pc:chgData name="Rob deKemp" userId="26657504-1aab-467a-88b1-a1249bc920d0" providerId="ADAL" clId="{AF186694-5EC4-4370-A5C7-D5DC4E26AB08}" dt="2023-05-02T20:47:51.656" v="347" actId="20577"/>
        <pc:sldMkLst>
          <pc:docMk/>
          <pc:sldMk cId="2545659868" sldId="265"/>
        </pc:sldMkLst>
        <pc:spChg chg="mod">
          <ac:chgData name="Rob deKemp" userId="26657504-1aab-467a-88b1-a1249bc920d0" providerId="ADAL" clId="{AF186694-5EC4-4370-A5C7-D5DC4E26AB08}" dt="2023-05-02T20:47:51.656" v="347" actId="20577"/>
          <ac:spMkLst>
            <pc:docMk/>
            <pc:sldMk cId="2545659868" sldId="265"/>
            <ac:spMk id="6151" creationId="{00000000-0000-0000-0000-000000000000}"/>
          </ac:spMkLst>
        </pc:spChg>
      </pc:sldChg>
      <pc:sldChg chg="modSp mod">
        <pc:chgData name="Rob deKemp" userId="26657504-1aab-467a-88b1-a1249bc920d0" providerId="ADAL" clId="{AF186694-5EC4-4370-A5C7-D5DC4E26AB08}" dt="2023-05-02T20:07:11.709" v="159" actId="20577"/>
        <pc:sldMkLst>
          <pc:docMk/>
          <pc:sldMk cId="3786696485" sldId="266"/>
        </pc:sldMkLst>
        <pc:spChg chg="mod">
          <ac:chgData name="Rob deKemp" userId="26657504-1aab-467a-88b1-a1249bc920d0" providerId="ADAL" clId="{AF186694-5EC4-4370-A5C7-D5DC4E26AB08}" dt="2023-05-02T20:07:11.709" v="159" actId="20577"/>
          <ac:spMkLst>
            <pc:docMk/>
            <pc:sldMk cId="3786696485" sldId="266"/>
            <ac:spMk id="6151" creationId="{00000000-0000-0000-0000-000000000000}"/>
          </ac:spMkLst>
        </pc:spChg>
      </pc:sldChg>
      <pc:sldChg chg="addSp delSp modSp add del mod ord">
        <pc:chgData name="Rob deKemp" userId="26657504-1aab-467a-88b1-a1249bc920d0" providerId="ADAL" clId="{AF186694-5EC4-4370-A5C7-D5DC4E26AB08}" dt="2023-05-02T20:53:11.288" v="379" actId="164"/>
        <pc:sldMkLst>
          <pc:docMk/>
          <pc:sldMk cId="218645169" sldId="267"/>
        </pc:sldMkLst>
        <pc:spChg chg="add mod">
          <ac:chgData name="Rob deKemp" userId="26657504-1aab-467a-88b1-a1249bc920d0" providerId="ADAL" clId="{AF186694-5EC4-4370-A5C7-D5DC4E26AB08}" dt="2023-05-02T20:38:09.273" v="269" actId="1076"/>
          <ac:spMkLst>
            <pc:docMk/>
            <pc:sldMk cId="218645169" sldId="267"/>
            <ac:spMk id="2" creationId="{0C59AC5A-FAE5-71FA-E006-8F21CD84600E}"/>
          </ac:spMkLst>
        </pc:spChg>
        <pc:spChg chg="add mod">
          <ac:chgData name="Rob deKemp" userId="26657504-1aab-467a-88b1-a1249bc920d0" providerId="ADAL" clId="{AF186694-5EC4-4370-A5C7-D5DC4E26AB08}" dt="2023-05-02T20:38:08.458" v="268" actId="1076"/>
          <ac:spMkLst>
            <pc:docMk/>
            <pc:sldMk cId="218645169" sldId="267"/>
            <ac:spMk id="3" creationId="{9F268965-EDA9-F902-41A1-D7E221AB79E1}"/>
          </ac:spMkLst>
        </pc:spChg>
        <pc:spChg chg="mod">
          <ac:chgData name="Rob deKemp" userId="26657504-1aab-467a-88b1-a1249bc920d0" providerId="ADAL" clId="{AF186694-5EC4-4370-A5C7-D5DC4E26AB08}" dt="2023-05-02T20:46:33.311" v="326" actId="20577"/>
          <ac:spMkLst>
            <pc:docMk/>
            <pc:sldMk cId="218645169" sldId="267"/>
            <ac:spMk id="4" creationId="{00000000-0000-0000-0000-000000000000}"/>
          </ac:spMkLst>
        </pc:spChg>
        <pc:spChg chg="mod">
          <ac:chgData name="Rob deKemp" userId="26657504-1aab-467a-88b1-a1249bc920d0" providerId="ADAL" clId="{AF186694-5EC4-4370-A5C7-D5DC4E26AB08}" dt="2023-05-02T20:51:09.128" v="364" actId="20577"/>
          <ac:spMkLst>
            <pc:docMk/>
            <pc:sldMk cId="218645169" sldId="267"/>
            <ac:spMk id="12" creationId="{F75F2ECB-A030-7164-518B-CC73DB617E3B}"/>
          </ac:spMkLst>
        </pc:spChg>
        <pc:spChg chg="add mod">
          <ac:chgData name="Rob deKemp" userId="26657504-1aab-467a-88b1-a1249bc920d0" providerId="ADAL" clId="{AF186694-5EC4-4370-A5C7-D5DC4E26AB08}" dt="2023-05-02T20:53:11.288" v="379" actId="164"/>
          <ac:spMkLst>
            <pc:docMk/>
            <pc:sldMk cId="218645169" sldId="267"/>
            <ac:spMk id="15" creationId="{61AF8A4B-35E0-D848-60ED-D0608D38DC2D}"/>
          </ac:spMkLst>
        </pc:spChg>
        <pc:spChg chg="add mod">
          <ac:chgData name="Rob deKemp" userId="26657504-1aab-467a-88b1-a1249bc920d0" providerId="ADAL" clId="{AF186694-5EC4-4370-A5C7-D5DC4E26AB08}" dt="2023-05-02T20:53:11.288" v="379" actId="164"/>
          <ac:spMkLst>
            <pc:docMk/>
            <pc:sldMk cId="218645169" sldId="267"/>
            <ac:spMk id="16" creationId="{FEECD87E-5D8D-15C7-3B29-9F8E2BA3D9FE}"/>
          </ac:spMkLst>
        </pc:spChg>
        <pc:grpChg chg="add del mod">
          <ac:chgData name="Rob deKemp" userId="26657504-1aab-467a-88b1-a1249bc920d0" providerId="ADAL" clId="{AF186694-5EC4-4370-A5C7-D5DC4E26AB08}" dt="2023-05-02T20:46:09.283" v="316" actId="478"/>
          <ac:grpSpMkLst>
            <pc:docMk/>
            <pc:sldMk cId="218645169" sldId="267"/>
            <ac:grpSpMk id="5" creationId="{7DBDE91F-48AD-B20D-417C-7CDCA72580CC}"/>
          </ac:grpSpMkLst>
        </pc:grpChg>
        <pc:grpChg chg="add mod">
          <ac:chgData name="Rob deKemp" userId="26657504-1aab-467a-88b1-a1249bc920d0" providerId="ADAL" clId="{AF186694-5EC4-4370-A5C7-D5DC4E26AB08}" dt="2023-05-02T20:53:11.288" v="379" actId="164"/>
          <ac:grpSpMkLst>
            <pc:docMk/>
            <pc:sldMk cId="218645169" sldId="267"/>
            <ac:grpSpMk id="17" creationId="{60C6BD7F-A08C-1D54-48CB-9D46852C7D70}"/>
          </ac:grpSpMkLst>
        </pc:grpChg>
        <pc:picChg chg="mod">
          <ac:chgData name="Rob deKemp" userId="26657504-1aab-467a-88b1-a1249bc920d0" providerId="ADAL" clId="{AF186694-5EC4-4370-A5C7-D5DC4E26AB08}" dt="2023-05-02T20:32:40.731" v="246" actId="164"/>
          <ac:picMkLst>
            <pc:docMk/>
            <pc:sldMk cId="218645169" sldId="267"/>
            <ac:picMk id="6" creationId="{B1B08C5A-4EF5-2A5E-9E84-4C42C804D257}"/>
          </ac:picMkLst>
        </pc:picChg>
        <pc:picChg chg="mod">
          <ac:chgData name="Rob deKemp" userId="26657504-1aab-467a-88b1-a1249bc920d0" providerId="ADAL" clId="{AF186694-5EC4-4370-A5C7-D5DC4E26AB08}" dt="2023-05-02T20:32:40.731" v="246" actId="164"/>
          <ac:picMkLst>
            <pc:docMk/>
            <pc:sldMk cId="218645169" sldId="267"/>
            <ac:picMk id="9" creationId="{B1B3706C-E1E2-F338-7F0F-5A908F744B91}"/>
          </ac:picMkLst>
        </pc:picChg>
        <pc:picChg chg="add mod">
          <ac:chgData name="Rob deKemp" userId="26657504-1aab-467a-88b1-a1249bc920d0" providerId="ADAL" clId="{AF186694-5EC4-4370-A5C7-D5DC4E26AB08}" dt="2023-05-02T20:53:11.288" v="379" actId="164"/>
          <ac:picMkLst>
            <pc:docMk/>
            <pc:sldMk cId="218645169" sldId="267"/>
            <ac:picMk id="13" creationId="{039118AA-1824-26E5-FACC-95064D173035}"/>
          </ac:picMkLst>
        </pc:picChg>
        <pc:picChg chg="add mod">
          <ac:chgData name="Rob deKemp" userId="26657504-1aab-467a-88b1-a1249bc920d0" providerId="ADAL" clId="{AF186694-5EC4-4370-A5C7-D5DC4E26AB08}" dt="2023-05-02T20:53:11.288" v="379" actId="164"/>
          <ac:picMkLst>
            <pc:docMk/>
            <pc:sldMk cId="218645169" sldId="267"/>
            <ac:picMk id="14" creationId="{0D8E95CE-B5F5-4597-B76D-5969A64D89B9}"/>
          </ac:picMkLst>
        </pc:picChg>
      </pc:sldChg>
      <pc:sldChg chg="add del">
        <pc:chgData name="Rob deKemp" userId="26657504-1aab-467a-88b1-a1249bc920d0" providerId="ADAL" clId="{AF186694-5EC4-4370-A5C7-D5DC4E26AB08}" dt="2023-05-02T20:46:04.620" v="313"/>
        <pc:sldMkLst>
          <pc:docMk/>
          <pc:sldMk cId="3262664963" sldId="267"/>
        </pc:sldMkLst>
      </pc:sldChg>
      <pc:sldChg chg="addSp modSp mod">
        <pc:chgData name="Rob deKemp" userId="26657504-1aab-467a-88b1-a1249bc920d0" providerId="ADAL" clId="{AF186694-5EC4-4370-A5C7-D5DC4E26AB08}" dt="2023-05-02T20:47:34.176" v="341" actId="20577"/>
        <pc:sldMkLst>
          <pc:docMk/>
          <pc:sldMk cId="1176960746" sldId="268"/>
        </pc:sldMkLst>
        <pc:spChg chg="mod">
          <ac:chgData name="Rob deKemp" userId="26657504-1aab-467a-88b1-a1249bc920d0" providerId="ADAL" clId="{AF186694-5EC4-4370-A5C7-D5DC4E26AB08}" dt="2023-05-02T20:47:34.176" v="341" actId="20577"/>
          <ac:spMkLst>
            <pc:docMk/>
            <pc:sldMk cId="1176960746" sldId="268"/>
            <ac:spMk id="6" creationId="{27146D1A-DA1B-14CD-CADD-4D0F0770BFB7}"/>
          </ac:spMkLst>
        </pc:spChg>
        <pc:spChg chg="add mod">
          <ac:chgData name="Rob deKemp" userId="26657504-1aab-467a-88b1-a1249bc920d0" providerId="ADAL" clId="{AF186694-5EC4-4370-A5C7-D5DC4E26AB08}" dt="2023-05-02T20:40:37.663" v="285" actId="164"/>
          <ac:spMkLst>
            <pc:docMk/>
            <pc:sldMk cId="1176960746" sldId="268"/>
            <ac:spMk id="9" creationId="{E0034B1F-563B-6553-9190-F1D8CA536448}"/>
          </ac:spMkLst>
        </pc:spChg>
        <pc:spChg chg="add mod">
          <ac:chgData name="Rob deKemp" userId="26657504-1aab-467a-88b1-a1249bc920d0" providerId="ADAL" clId="{AF186694-5EC4-4370-A5C7-D5DC4E26AB08}" dt="2023-05-02T20:40:37.663" v="285" actId="164"/>
          <ac:spMkLst>
            <pc:docMk/>
            <pc:sldMk cId="1176960746" sldId="268"/>
            <ac:spMk id="12" creationId="{9681F38A-95F7-8737-66C8-5B4D1996F519}"/>
          </ac:spMkLst>
        </pc:spChg>
        <pc:spChg chg="add mod">
          <ac:chgData name="Rob deKemp" userId="26657504-1aab-467a-88b1-a1249bc920d0" providerId="ADAL" clId="{AF186694-5EC4-4370-A5C7-D5DC4E26AB08}" dt="2023-05-02T20:40:37.663" v="285" actId="164"/>
          <ac:spMkLst>
            <pc:docMk/>
            <pc:sldMk cId="1176960746" sldId="268"/>
            <ac:spMk id="13" creationId="{5744F1FC-DFA4-D120-1CA4-06CA5690143B}"/>
          </ac:spMkLst>
        </pc:spChg>
        <pc:grpChg chg="add mod">
          <ac:chgData name="Rob deKemp" userId="26657504-1aab-467a-88b1-a1249bc920d0" providerId="ADAL" clId="{AF186694-5EC4-4370-A5C7-D5DC4E26AB08}" dt="2023-05-02T20:44:03.957" v="294" actId="1076"/>
          <ac:grpSpMkLst>
            <pc:docMk/>
            <pc:sldMk cId="1176960746" sldId="268"/>
            <ac:grpSpMk id="14" creationId="{BBB314A8-42ED-EFC6-B52E-4900B42FB316}"/>
          </ac:grpSpMkLst>
        </pc:grpChg>
        <pc:picChg chg="mod">
          <ac:chgData name="Rob deKemp" userId="26657504-1aab-467a-88b1-a1249bc920d0" providerId="ADAL" clId="{AF186694-5EC4-4370-A5C7-D5DC4E26AB08}" dt="2023-05-02T20:40:37.663" v="285" actId="164"/>
          <ac:picMkLst>
            <pc:docMk/>
            <pc:sldMk cId="1176960746" sldId="268"/>
            <ac:picMk id="2" creationId="{2E470A36-86D1-7D40-4213-F87C08E46FCD}"/>
          </ac:picMkLst>
        </pc:picChg>
        <pc:picChg chg="mod">
          <ac:chgData name="Rob deKemp" userId="26657504-1aab-467a-88b1-a1249bc920d0" providerId="ADAL" clId="{AF186694-5EC4-4370-A5C7-D5DC4E26AB08}" dt="2023-05-02T20:40:37.663" v="285" actId="164"/>
          <ac:picMkLst>
            <pc:docMk/>
            <pc:sldMk cId="1176960746" sldId="268"/>
            <ac:picMk id="3" creationId="{901D2430-784A-D503-E8DB-A218CFA6EC0E}"/>
          </ac:picMkLst>
        </pc:picChg>
        <pc:picChg chg="mod">
          <ac:chgData name="Rob deKemp" userId="26657504-1aab-467a-88b1-a1249bc920d0" providerId="ADAL" clId="{AF186694-5EC4-4370-A5C7-D5DC4E26AB08}" dt="2023-05-02T20:40:37.663" v="285" actId="164"/>
          <ac:picMkLst>
            <pc:docMk/>
            <pc:sldMk cId="1176960746" sldId="268"/>
            <ac:picMk id="5" creationId="{97442154-3E20-AC35-06CA-62C79D3A8FC1}"/>
          </ac:picMkLst>
        </pc:picChg>
      </pc:sldChg>
      <pc:sldChg chg="add del">
        <pc:chgData name="Rob deKemp" userId="26657504-1aab-467a-88b1-a1249bc920d0" providerId="ADAL" clId="{AF186694-5EC4-4370-A5C7-D5DC4E26AB08}" dt="2023-05-02T20:44:28.976" v="295" actId="47"/>
        <pc:sldMkLst>
          <pc:docMk/>
          <pc:sldMk cId="1523154820" sldId="269"/>
        </pc:sldMkLst>
      </pc:sldChg>
      <pc:sldChg chg="addSp delSp modSp add del mod">
        <pc:chgData name="Rob deKemp" userId="26657504-1aab-467a-88b1-a1249bc920d0" providerId="ADAL" clId="{AF186694-5EC4-4370-A5C7-D5DC4E26AB08}" dt="2023-05-02T20:46:24.944" v="317" actId="47"/>
        <pc:sldMkLst>
          <pc:docMk/>
          <pc:sldMk cId="2865910704" sldId="269"/>
        </pc:sldMkLst>
        <pc:spChg chg="mod">
          <ac:chgData name="Rob deKemp" userId="26657504-1aab-467a-88b1-a1249bc920d0" providerId="ADAL" clId="{AF186694-5EC4-4370-A5C7-D5DC4E26AB08}" dt="2023-05-02T20:44:36.794" v="303" actId="20577"/>
          <ac:spMkLst>
            <pc:docMk/>
            <pc:sldMk cId="2865910704" sldId="269"/>
            <ac:spMk id="4" creationId="{00000000-0000-0000-0000-000000000000}"/>
          </ac:spMkLst>
        </pc:spChg>
        <pc:spChg chg="del mod">
          <ac:chgData name="Rob deKemp" userId="26657504-1aab-467a-88b1-a1249bc920d0" providerId="ADAL" clId="{AF186694-5EC4-4370-A5C7-D5DC4E26AB08}" dt="2023-05-02T20:44:42.305" v="307"/>
          <ac:spMkLst>
            <pc:docMk/>
            <pc:sldMk cId="2865910704" sldId="269"/>
            <ac:spMk id="12" creationId="{F75F2ECB-A030-7164-518B-CC73DB617E3B}"/>
          </ac:spMkLst>
        </pc:spChg>
        <pc:grpChg chg="add del">
          <ac:chgData name="Rob deKemp" userId="26657504-1aab-467a-88b1-a1249bc920d0" providerId="ADAL" clId="{AF186694-5EC4-4370-A5C7-D5DC4E26AB08}" dt="2023-05-02T20:46:05.958" v="314" actId="478"/>
          <ac:grpSpMkLst>
            <pc:docMk/>
            <pc:sldMk cId="2865910704" sldId="269"/>
            <ac:grpSpMk id="5" creationId="{7DBDE91F-48AD-B20D-417C-7CDCA72580CC}"/>
          </ac:grpSpMkLst>
        </pc:grpChg>
      </pc:sldChg>
      <pc:sldChg chg="add">
        <pc:chgData name="Rob deKemp" userId="26657504-1aab-467a-88b1-a1249bc920d0" providerId="ADAL" clId="{AF186694-5EC4-4370-A5C7-D5DC4E26AB08}" dt="2023-05-02T20:44:42.303" v="305"/>
        <pc:sldMkLst>
          <pc:docMk/>
          <pc:sldMk cId="710923288" sldId="270"/>
        </pc:sldMkLst>
      </pc:sldChg>
    </pc:docChg>
  </pc:docChgLst>
</pc:chgInfo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5/2/2023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5/2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5/2/2023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5/2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5/2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5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5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5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5/2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5/2/202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5/2/202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5/2/202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5/2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5/2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5/2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5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5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5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5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5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5/2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5/2/202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5/2/202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5/2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5/2/202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5/2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5/2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5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5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5/2/2023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5/2/2023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5/2/2023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5/2/2023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5/2/2023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5/2/2023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5/2/2023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5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5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tabLst>
                <a:tab pos="3330575" algn="l"/>
              </a:tabLst>
            </a:pPr>
            <a:r>
              <a:rPr lang="en-CA" sz="2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xponential Dosing to Standardize Myocardial Perfusion Image Quality with Rubidium-82 PET</a:t>
            </a:r>
            <a:endParaRPr lang="en-US" sz="28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marR="0">
              <a:spcBef>
                <a:spcPts val="0"/>
              </a:spcBef>
              <a:spcAft>
                <a:spcPts val="800"/>
              </a:spcAft>
            </a:pPr>
            <a:r>
              <a:rPr lang="en-CA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nahita Tavoosi</a:t>
            </a:r>
            <a:r>
              <a:rPr lang="en-CA" sz="16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</a:t>
            </a:r>
            <a:r>
              <a:rPr lang="en-CA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Ritika Khetarpal</a:t>
            </a:r>
            <a:r>
              <a:rPr lang="en-CA" sz="16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lang="en-CA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R. Glenn Wells</a:t>
            </a:r>
            <a:r>
              <a:rPr lang="en-CA" sz="16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</a:t>
            </a:r>
            <a:r>
              <a:rPr lang="en-CA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Rob S.B. Beanlands</a:t>
            </a:r>
            <a:r>
              <a:rPr lang="en-CA" sz="16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</a:t>
            </a:r>
            <a:r>
              <a:rPr lang="en-CA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Robert A. deKemp</a:t>
            </a:r>
            <a:r>
              <a:rPr lang="en-CA" sz="16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</a:t>
            </a:r>
            <a:endParaRPr lang="en-US" sz="16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marL="0" marR="0">
              <a:spcBef>
                <a:spcPts val="0"/>
              </a:spcBef>
              <a:spcAft>
                <a:spcPts val="800"/>
              </a:spcAft>
            </a:pPr>
            <a:r>
              <a:rPr lang="en-CA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</a:t>
            </a:r>
            <a:r>
              <a:rPr lang="en-CA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epartment of Medicine (Cardiology), University of Ottawa Heart Institute, Ottawa, Canada</a:t>
            </a:r>
            <a:endParaRPr lang="en-US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marL="0" marR="0">
              <a:spcBef>
                <a:spcPts val="0"/>
              </a:spcBef>
              <a:spcAft>
                <a:spcPts val="800"/>
              </a:spcAft>
            </a:pPr>
            <a:r>
              <a:rPr lang="en-CA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lang="en-CA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chool of Interdisciplinary Science (Life Sciences), McMaster University, Hamilton, Canada</a:t>
            </a:r>
            <a:endParaRPr lang="en-US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endParaRPr lang="en-US" altLang="en-US" sz="40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A1386F1-44F8-604A-848D-917F2B9393D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26687"/>
          <a:stretch/>
        </p:blipFill>
        <p:spPr>
          <a:xfrm>
            <a:off x="3048000" y="3927503"/>
            <a:ext cx="2270267" cy="1842751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AE01D2C5-3CCF-CE82-6702-0AC946AF744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95400" y="3945203"/>
            <a:ext cx="1617268" cy="1842752"/>
          </a:xfrm>
          <a:prstGeom prst="rect">
            <a:avLst/>
          </a:prstGeom>
        </p:spPr>
      </p:pic>
      <p:pic>
        <p:nvPicPr>
          <p:cNvPr id="7" name="Picture 6" descr="Robert deKemp email address &amp; phone number | University of Ottawa Heart  Institute Head Imaging Physicist contact information - RocketReach">
            <a:extLst>
              <a:ext uri="{FF2B5EF4-FFF2-40B4-BE49-F238E27FC236}">
                <a16:creationId xmlns:a16="http://schemas.microsoft.com/office/drawing/2014/main" id="{067ABB67-A034-51A7-F1CE-F0D33DC900A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45579" y="3945203"/>
            <a:ext cx="1818613" cy="1818613"/>
          </a:xfrm>
          <a:prstGeom prst="rect">
            <a:avLst/>
          </a:prstGeom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610600" cy="4739738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400" dirty="0">
                <a:latin typeface="+mj-lt"/>
              </a:rPr>
              <a:t>1-</a:t>
            </a:r>
            <a:r>
              <a:rPr lang="en-US" sz="2400" dirty="0">
                <a:solidFill>
                  <a:srgbClr val="000000"/>
                </a:solidFill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Imaging with cardiac PET is susceptible to the patient’s body habitus, as the increase in body weight leads to lower quality images </a:t>
            </a:r>
          </a:p>
          <a:p>
            <a:pPr marL="0" indent="0">
              <a:buNone/>
            </a:pPr>
            <a:endParaRPr lang="en-US" sz="2400" dirty="0">
              <a:solidFill>
                <a:srgbClr val="000000"/>
              </a:solidFill>
              <a:latin typeface="+mj-lt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altLang="en-US" sz="2400" dirty="0">
                <a:latin typeface="+mj-lt"/>
              </a:rPr>
              <a:t>2- </a:t>
            </a:r>
            <a:r>
              <a:rPr lang="en-US" sz="2400" dirty="0">
                <a:solidFill>
                  <a:srgbClr val="000000"/>
                </a:solidFill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The current guidelines advise a single constant dose of Rb-82 for PET MPI or a dose by weight (e.g. MBq/kg), which still has the limitation of poor image quality in obese patients</a:t>
            </a:r>
          </a:p>
          <a:p>
            <a:pPr marL="0" indent="0">
              <a:buNone/>
            </a:pPr>
            <a:endParaRPr lang="en-US" sz="2400" dirty="0">
              <a:solidFill>
                <a:srgbClr val="000000"/>
              </a:solidFill>
              <a:latin typeface="+mj-lt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2400" dirty="0">
                <a:solidFill>
                  <a:srgbClr val="000000"/>
                </a:solidFill>
                <a:latin typeface="+mj-lt"/>
                <a:cs typeface="Times New Roman" panose="02020603050405020304" pitchFamily="18" charset="0"/>
              </a:rPr>
              <a:t>3- The aim of this study </a:t>
            </a:r>
            <a:r>
              <a:rPr lang="en-US" sz="2400" dirty="0">
                <a:solidFill>
                  <a:srgbClr val="000000"/>
                </a:solidFill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was to investigate whether Rb-82 activity administered as a squared function of patient weight (exponential dosing) can help standardize image quality across a wide range of body sizes</a:t>
            </a:r>
            <a:r>
              <a:rPr lang="en-US" altLang="en-US" sz="2400" dirty="0">
                <a:latin typeface="+mj-lt"/>
              </a:rPr>
              <a:t> </a:t>
            </a:r>
          </a:p>
          <a:p>
            <a:pPr marL="0" indent="0">
              <a:buNone/>
            </a:pPr>
            <a:endParaRPr lang="en-US" altLang="en-US" sz="2800" dirty="0"/>
          </a:p>
          <a:p>
            <a:pPr marL="0" indent="0">
              <a:buNone/>
            </a:pPr>
            <a:endParaRPr lang="en-US" altLang="en-US" sz="28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type:</a:t>
            </a:r>
            <a:endParaRPr lang="en-US" altLang="en-US" sz="2400" dirty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trospective/case control/cohort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subjects: </a:t>
            </a:r>
            <a:r>
              <a:rPr lang="en-CA" sz="2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wo sequential cohorts of N=60 patients were matched by patient weight. Rest and dipyridamole stress Rb-82 PET imaging was performed using 0.1 MBq/kg</a:t>
            </a:r>
            <a:r>
              <a:rPr lang="en-CA" sz="20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CA" sz="2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xponential and 9 MBq/kg proportional dosing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endpoints:</a:t>
            </a:r>
          </a:p>
          <a:p>
            <a:pPr marL="514350" lvl="1" indent="-514350">
              <a:buFont typeface="Times New Roman" pitchFamily="18" charset="0"/>
              <a:buAutoNum type="alphaUcPeriod"/>
            </a:pPr>
            <a:r>
              <a:rPr lang="en-CA" sz="20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Quantitative image analysis</a:t>
            </a:r>
            <a:r>
              <a:rPr lang="en-CA" sz="2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 Myocardium-to-blood contrast-to-noise (CNR) ratio and blood background signal-to-noise ratio (SNR)</a:t>
            </a:r>
          </a:p>
          <a:p>
            <a:pPr marL="514350" lvl="1" indent="-514350">
              <a:buFont typeface="Times New Roman" pitchFamily="18" charset="0"/>
              <a:buAutoNum type="alphaUcPeriod"/>
            </a:pPr>
            <a:r>
              <a:rPr lang="en-CA" sz="20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isual image quality</a:t>
            </a:r>
            <a:r>
              <a:rPr lang="en-CA" sz="2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2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CG-gated image quality scores (IQS) in the heart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75F2ECB-A030-7164-518B-CC73DB617E3B}"/>
              </a:ext>
            </a:extLst>
          </p:cNvPr>
          <p:cNvSpPr txBox="1"/>
          <p:nvPr/>
        </p:nvSpPr>
        <p:spPr>
          <a:xfrm>
            <a:off x="533400" y="4457454"/>
            <a:ext cx="81534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82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b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PET dosing protocols as a function of patient body weight. (A) Constant, proportional and exponential dosing curves intersect at a common injected activity (810 MBq) and average patient body weight (90 kg). (B) Predicted changes in signal-to-noise ratio (SNR) as a function of patient weight for 3 different dosing methods.</a:t>
            </a:r>
            <a:endParaRPr lang="en-US" dirty="0"/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60C6BD7F-A08C-1D54-48CB-9D46852C7D70}"/>
              </a:ext>
            </a:extLst>
          </p:cNvPr>
          <p:cNvGrpSpPr/>
          <p:nvPr/>
        </p:nvGrpSpPr>
        <p:grpSpPr>
          <a:xfrm>
            <a:off x="576803" y="1575947"/>
            <a:ext cx="8033796" cy="2652321"/>
            <a:chOff x="576803" y="1575947"/>
            <a:chExt cx="8033796" cy="2652321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039118AA-1824-26E5-FACC-95064D17303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6803" y="1575947"/>
              <a:ext cx="3867174" cy="2652321"/>
            </a:xfrm>
            <a:prstGeom prst="rect">
              <a:avLst/>
            </a:prstGeom>
            <a:noFill/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0D8E95CE-B5F5-4597-B76D-5969A64D89B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63579" y="1579513"/>
              <a:ext cx="4047020" cy="2648755"/>
            </a:xfrm>
            <a:prstGeom prst="rect">
              <a:avLst/>
            </a:prstGeom>
            <a:noFill/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61AF8A4B-35E0-D848-60ED-D0608D38DC2D}"/>
                </a:ext>
              </a:extLst>
            </p:cNvPr>
            <p:cNvSpPr txBox="1"/>
            <p:nvPr/>
          </p:nvSpPr>
          <p:spPr>
            <a:xfrm>
              <a:off x="685800" y="1575947"/>
              <a:ext cx="609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b="1" dirty="0"/>
                <a:t>A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FEECD87E-5D8D-15C7-3B29-9F8E2BA3D9FE}"/>
                </a:ext>
              </a:extLst>
            </p:cNvPr>
            <p:cNvSpPr txBox="1"/>
            <p:nvPr/>
          </p:nvSpPr>
          <p:spPr>
            <a:xfrm>
              <a:off x="4694659" y="1575947"/>
              <a:ext cx="609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b="1" dirty="0"/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75F2ECB-A030-7164-518B-CC73DB617E3B}"/>
              </a:ext>
            </a:extLst>
          </p:cNvPr>
          <p:cNvSpPr txBox="1"/>
          <p:nvPr/>
        </p:nvSpPr>
        <p:spPr>
          <a:xfrm>
            <a:off x="533400" y="4457454"/>
            <a:ext cx="8153400" cy="15770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CA" sz="16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82</a:t>
            </a:r>
            <a:r>
              <a:rPr lang="en-CA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b PET visual image quality score (IQS</a:t>
            </a:r>
            <a:r>
              <a:rPr lang="en-CA" sz="1600" baseline="-25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ART</a:t>
            </a:r>
            <a:r>
              <a:rPr lang="en-CA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</a:t>
            </a:r>
            <a:r>
              <a:rPr lang="en-CA" sz="1600" b="1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ecreased</a:t>
            </a:r>
            <a:r>
              <a:rPr lang="en-CA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by weight (A) in the proportional dosing group (orange) but was </a:t>
            </a:r>
            <a:r>
              <a:rPr lang="en-CA" sz="1600" b="1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onstant</a:t>
            </a:r>
            <a:r>
              <a:rPr lang="en-CA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in the exponential dosing group (blue).  There was no difference in the median ECG-gated image quality score (B) between dosing cohorts (P = 0.11)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lnSpc>
                <a:spcPct val="107000"/>
              </a:lnSpc>
              <a:spcBef>
                <a:spcPts val="1200"/>
              </a:spcBef>
              <a:spcAft>
                <a:spcPts val="0"/>
              </a:spcAft>
            </a:pPr>
            <a:r>
              <a:rPr lang="en-CA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ines of best-fit are </a:t>
            </a:r>
            <a:r>
              <a:rPr lang="en-CA" sz="1600" b="1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QS </a:t>
            </a:r>
            <a:r>
              <a:rPr lang="en-CA" sz="1600" b="1" dirty="0">
                <a:effectLst/>
                <a:latin typeface="Cambria Math" panose="02040503050406030204" pitchFamily="18" charset="0"/>
                <a:ea typeface="Calibri" panose="020F0502020204030204" pitchFamily="34" charset="0"/>
                <a:cs typeface="Cambria Math" panose="02040503050406030204" pitchFamily="18" charset="0"/>
              </a:rPr>
              <a:t>∝</a:t>
            </a:r>
            <a:r>
              <a:rPr lang="en-CA" sz="1600" dirty="0">
                <a:effectLst/>
                <a:latin typeface="Cambria Math" panose="02040503050406030204" pitchFamily="18" charset="0"/>
                <a:ea typeface="Calibri" panose="020F0502020204030204" pitchFamily="34" charset="0"/>
                <a:cs typeface="Cambria Math" panose="02040503050406030204" pitchFamily="18" charset="0"/>
              </a:rPr>
              <a:t> </a:t>
            </a:r>
            <a:r>
              <a:rPr lang="en-CA" sz="1600" b="1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eight </a:t>
            </a:r>
            <a:r>
              <a:rPr lang="en-CA" sz="1600" b="1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β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US" dirty="0"/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7DBDE91F-48AD-B20D-417C-7CDCA72580CC}"/>
              </a:ext>
            </a:extLst>
          </p:cNvPr>
          <p:cNvGrpSpPr/>
          <p:nvPr/>
        </p:nvGrpSpPr>
        <p:grpSpPr>
          <a:xfrm>
            <a:off x="1464396" y="1530291"/>
            <a:ext cx="6144175" cy="2895600"/>
            <a:chOff x="1464396" y="1530291"/>
            <a:chExt cx="6144175" cy="2895600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B1B08C5A-4EF5-2A5E-9E84-4C42C804D25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-2765" b="-1"/>
            <a:stretch/>
          </p:blipFill>
          <p:spPr bwMode="auto">
            <a:xfrm>
              <a:off x="4535806" y="1555005"/>
              <a:ext cx="3072765" cy="2832735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B1B3706C-E1E2-F338-7F0F-5A908F744B9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64396" y="1530291"/>
              <a:ext cx="3066415" cy="2895600"/>
            </a:xfrm>
            <a:prstGeom prst="rect">
              <a:avLst/>
            </a:prstGeom>
            <a:noFill/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0C59AC5A-FAE5-71FA-E006-8F21CD84600E}"/>
                </a:ext>
              </a:extLst>
            </p:cNvPr>
            <p:cNvSpPr txBox="1"/>
            <p:nvPr/>
          </p:nvSpPr>
          <p:spPr>
            <a:xfrm>
              <a:off x="1464480" y="1568164"/>
              <a:ext cx="533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b="1" dirty="0"/>
                <a:t>A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9F268965-EDA9-F902-41A1-D7E221AB79E1}"/>
                </a:ext>
              </a:extLst>
            </p:cNvPr>
            <p:cNvSpPr txBox="1"/>
            <p:nvPr/>
          </p:nvSpPr>
          <p:spPr>
            <a:xfrm>
              <a:off x="4488694" y="1568164"/>
              <a:ext cx="533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b="1" dirty="0"/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71092328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228600" y="1524000"/>
            <a:ext cx="8534400" cy="46482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7146D1A-DA1B-14CD-CADD-4D0F0770BFB7}"/>
              </a:ext>
            </a:extLst>
          </p:cNvPr>
          <p:cNvSpPr txBox="1"/>
          <p:nvPr/>
        </p:nvSpPr>
        <p:spPr>
          <a:xfrm>
            <a:off x="467497" y="4341250"/>
            <a:ext cx="811367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CA" sz="16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82</a:t>
            </a:r>
            <a:r>
              <a:rPr lang="en-CA" sz="16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Rb PET contrast-to-noise ratio (CNR) </a:t>
            </a:r>
            <a:r>
              <a:rPr lang="en-CA" sz="1600" b="1" i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ecreases</a:t>
            </a:r>
            <a:r>
              <a:rPr lang="en-CA" sz="16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with increasing patient body weight in the proportional dosing cohort but </a:t>
            </a:r>
            <a:r>
              <a:rPr lang="en-CA" sz="1600" dirty="0">
                <a:latin typeface="Calibri" panose="020F0502020204030204" pitchFamily="34" charset="0"/>
                <a:ea typeface="Calibri" panose="020F0502020204030204" pitchFamily="34" charset="0"/>
              </a:rPr>
              <a:t>does </a:t>
            </a:r>
            <a:r>
              <a:rPr lang="en-CA" sz="1600" b="1" i="1" dirty="0">
                <a:latin typeface="Calibri" panose="020F0502020204030204" pitchFamily="34" charset="0"/>
                <a:ea typeface="Calibri" panose="020F0502020204030204" pitchFamily="34" charset="0"/>
              </a:rPr>
              <a:t>not</a:t>
            </a:r>
            <a:r>
              <a:rPr lang="en-CA" sz="1600" b="1" i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ecrease </a:t>
            </a:r>
            <a:r>
              <a:rPr lang="en-CA" sz="16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n the exponential dosing cohort for both ECG-gated (A) and ungated static (B) images.  Box-plots of CNR</a:t>
            </a:r>
            <a:r>
              <a:rPr lang="en-CA" sz="1600" baseline="-25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ART</a:t>
            </a:r>
            <a:r>
              <a:rPr lang="en-CA" sz="16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in (C) show a highly significant effect of exponential dosing to reduce the variability in image quality (CNR</a:t>
            </a:r>
            <a:r>
              <a:rPr lang="en-CA" sz="1600" baseline="-25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ART</a:t>
            </a:r>
            <a:r>
              <a:rPr lang="en-CA" sz="16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 among patients for both static and gated reconstructions.</a:t>
            </a:r>
          </a:p>
          <a:p>
            <a:pPr algn="just"/>
            <a:r>
              <a:rPr lang="en-CA" sz="16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(*** P &lt; 0.001 lower cohort variance versus proportional dosing). </a:t>
            </a:r>
            <a:endParaRPr lang="en-US" sz="1600" dirty="0"/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BBB314A8-42ED-EFC6-B52E-4900B42FB316}"/>
              </a:ext>
            </a:extLst>
          </p:cNvPr>
          <p:cNvGrpSpPr/>
          <p:nvPr/>
        </p:nvGrpSpPr>
        <p:grpSpPr>
          <a:xfrm>
            <a:off x="328732" y="1593326"/>
            <a:ext cx="8334135" cy="2702155"/>
            <a:chOff x="272047" y="1520299"/>
            <a:chExt cx="8334135" cy="2702155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2E470A36-86D1-7D40-4213-F87C08E46FC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97" r="2031" b="2715"/>
            <a:stretch/>
          </p:blipFill>
          <p:spPr bwMode="auto">
            <a:xfrm>
              <a:off x="272047" y="1543654"/>
              <a:ext cx="2763400" cy="2676368"/>
            </a:xfrm>
            <a:prstGeom prst="rect">
              <a:avLst/>
            </a:prstGeom>
            <a:noFill/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901D2430-784A-D503-E8DB-A218CFA6EC0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067" b="3075"/>
            <a:stretch/>
          </p:blipFill>
          <p:spPr bwMode="auto">
            <a:xfrm>
              <a:off x="3074775" y="1538771"/>
              <a:ext cx="2571873" cy="2666464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97442154-3E20-AC35-06CA-62C79D3A8FC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9" r="1" b="2126"/>
            <a:stretch/>
          </p:blipFill>
          <p:spPr bwMode="auto">
            <a:xfrm>
              <a:off x="5711831" y="1541221"/>
              <a:ext cx="2894351" cy="2681233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0034B1F-563B-6553-9190-F1D8CA536448}"/>
                </a:ext>
              </a:extLst>
            </p:cNvPr>
            <p:cNvSpPr txBox="1"/>
            <p:nvPr/>
          </p:nvSpPr>
          <p:spPr>
            <a:xfrm>
              <a:off x="364623" y="1538771"/>
              <a:ext cx="4899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b="1" dirty="0"/>
                <a:t>A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9681F38A-95F7-8737-66C8-5B4D1996F519}"/>
                </a:ext>
              </a:extLst>
            </p:cNvPr>
            <p:cNvSpPr txBox="1"/>
            <p:nvPr/>
          </p:nvSpPr>
          <p:spPr>
            <a:xfrm>
              <a:off x="2961051" y="1525634"/>
              <a:ext cx="4899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b="1" dirty="0"/>
                <a:t>B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5744F1FC-DFA4-D120-1CA4-06CA5690143B}"/>
                </a:ext>
              </a:extLst>
            </p:cNvPr>
            <p:cNvSpPr txBox="1"/>
            <p:nvPr/>
          </p:nvSpPr>
          <p:spPr>
            <a:xfrm>
              <a:off x="5685616" y="1520299"/>
              <a:ext cx="4899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b="1" dirty="0"/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</a:t>
            </a:r>
            <a:r>
              <a:rPr lang="en-CA" sz="28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findings show more consistent image quality (CNR, SNR, IQS) across all patient weights for both static and gated images when using exponential dosing compared to proportional weight-based dosing</a:t>
            </a:r>
          </a:p>
          <a:p>
            <a:pPr marL="0" indent="0">
              <a:buNone/>
            </a:pPr>
            <a:endParaRPr lang="en-CA" sz="28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CA" sz="28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- This approach </a:t>
            </a:r>
            <a:r>
              <a:rPr lang="en-CA" sz="2800" dirty="0">
                <a:solidFill>
                  <a:srgbClr val="201F1E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nables better standardization of image quality without increasing radiation dose to the population as a whole</a:t>
            </a:r>
            <a:endParaRPr lang="en-US" sz="28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altLang="en-US" sz="2800" dirty="0"/>
              <a:t> 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7</TotalTime>
  <Words>668</Words>
  <Application>Microsoft Office PowerPoint</Application>
  <PresentationFormat>On-screen Show (4:3)</PresentationFormat>
  <Paragraphs>52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7</vt:i4>
      </vt:variant>
    </vt:vector>
  </HeadingPairs>
  <TitlesOfParts>
    <vt:vector size="16" baseType="lpstr">
      <vt:lpstr>Arial</vt:lpstr>
      <vt:lpstr>Arial Narrow</vt:lpstr>
      <vt:lpstr>Calibri</vt:lpstr>
      <vt:lpstr>Cambria Math</vt:lpstr>
      <vt:lpstr>SsykbnAdvPTimes</vt:lpstr>
      <vt:lpstr>Times New Roman</vt:lpstr>
      <vt:lpstr>2_Office Theme</vt:lpstr>
      <vt:lpstr>Custom Design</vt:lpstr>
      <vt:lpstr>1_Custom Design</vt:lpstr>
      <vt:lpstr>Exponential Dosing to Standardize Myocardial Perfusion Image Quality with Rubidium-82 PET</vt:lpstr>
      <vt:lpstr>BACKGROUND</vt:lpstr>
      <vt:lpstr>METHODS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Rob deKemp</cp:lastModifiedBy>
  <cp:revision>97</cp:revision>
  <dcterms:created xsi:type="dcterms:W3CDTF">2011-04-18T21:44:13Z</dcterms:created>
  <dcterms:modified xsi:type="dcterms:W3CDTF">2023-05-02T20:53:15Z</dcterms:modified>
</cp:coreProperties>
</file>